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8372" autoAdjust="0"/>
    <p:restoredTop sz="94660"/>
  </p:normalViewPr>
  <p:slideViewPr>
    <p:cSldViewPr snapToGrid="0">
      <p:cViewPr>
        <p:scale>
          <a:sx n="77" d="100"/>
          <a:sy n="77" d="100"/>
        </p:scale>
        <p:origin x="168" y="6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8ED5F-9CBC-4D7D-89F5-29CCEC41352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0CF520-E31E-4064-BDBB-D7BB3FA7FE5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B3EEF68-B7BF-4AC2-80DE-2C89ED4AB4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F3360AE-8E10-4C54-B923-3792F6012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DD5705E-6F5B-4F5E-8E3A-06BBEE8238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0252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CED4BD-2470-4B23-9E48-342CDBEE5E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21886D-19DA-498F-B124-18C0F41D4F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5B41097-CE0D-44A2-A583-1B932F8765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86EC07-B54D-429F-A97F-F43A0223A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CA6DDC-2680-4430-B2EC-B17E77A67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254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855085F-7A48-47CC-9CF8-7BEB3F2311F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72B950D-A525-4149-9034-2C5EF3CF53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C5EED9C-3627-4AF5-9AAC-333099019C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5D6C91-A1E1-4A8A-8DFE-A34EAFBF11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C611E3-0A53-4A84-8A03-F5A29BFEA5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850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18FBCD-4179-415F-8648-6D9AAD3036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9D3623-5DC1-426C-9EF6-B3899BC272E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9376897-9EBA-41F0-B6E2-1635FA9273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C9C5F5-160B-4643-9FFB-2D7B1442B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04F5BC-4DD0-42B6-A9D9-D63C38094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151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DD714C-9543-496F-9CF4-B3218E434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83EAABB-0762-47D7-995F-07F0DD86401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6C9F94-9F06-4131-8AEE-A603D2671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336173-FF4B-472C-8854-CC1EE2489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923932-C9CA-42E5-B9DC-DD07740826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090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414A48-C0F1-464A-843A-6BBED232F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32D6807-52C5-44BB-9C6B-084FCF94C2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AF0C8E2-DBD5-42C1-9401-DA239FC6AB8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A969ED6-9810-45BD-98A9-BD8E093733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B5B6D2-E9A8-4389-A916-93B26E3266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EBB4B4-6A0E-4734-91B3-EACE412416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39390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205417-2B40-45B6-A086-DF555988AC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CD1F1D-EF6A-48CB-8B01-F99286C10E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FE1BE58-B8FD-4652-8EA6-2B257C06396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70D20D7C-42C5-4670-80E6-8EA7A89DA1D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C4BDA5D-7ECA-4863-888D-9292C91CA37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EF1D493-9F04-4F63-9065-5FA41CBEC6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D81450-84A7-4645-8F33-6484C2CFAF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149696-5E9D-41D8-AA0B-8E4C661A04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8507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BFA405-04B3-4730-8358-7DA1D5FFC1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CBB9A90-4E35-42AF-B5D6-C606936C43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5AD58AB-BB36-4384-8F99-A3B1155077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F22ACC-7A6B-46BA-981C-1862D9BBAD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631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9700264-8AF3-43E9-8AA4-76A9AFFDAA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898DDF4-5A2B-43BE-B80D-6E9471FE5A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EEF6BA-A0C5-49D6-BB1B-E42763FDE0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566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D32C4D-2B60-4DD5-97FC-3B3E66B367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7E41A9C-0888-4B2F-B675-380B2EA39A7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D70607D-A591-424B-8955-CBCDB09395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FE45CC-769E-4C2B-96DE-62A72A1D97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7C5CEE6-F2A1-46E4-A956-A2A0D92C11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18E34C7-9AF1-48C6-AC61-5696AA8268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41081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C87D0A-9431-4B8F-8D79-7CD4891CA2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F1B081D-61D3-4DB5-B607-9DF55895B52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39F3986-B895-4AAB-97A6-F8AF9E2F0C9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8B99F0E-F6CC-4E96-8048-3F982E7494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D9A4EB-2AD4-4601-AD3E-6B1C41A22A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B7BC2E-EBF7-4F6B-9864-FC4ACDADA5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811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22F1B0A-C1E9-41B3-9EFF-6E1521ECC0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B498B5-2E17-4A25-8F8D-8F73C86D9E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73C4F4-6A93-44C3-BC56-3B22673C28C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0AC89D-BDB4-4857-9B57-21EE9F0994DB}" type="datetimeFigureOut">
              <a:rPr lang="en-US" smtClean="0"/>
              <a:t>11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3ED6D0-F801-4B83-A77D-995C4E6346A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B8AB81-38FA-4BD2-B7E8-2DD17E494E6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ECEA64-6AF9-4A76-B774-4F069E9A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11342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2BD51629-E910-4CEA-928F-8B945FDDBF3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616333"/>
              </p:ext>
            </p:extLst>
          </p:nvPr>
        </p:nvGraphicFramePr>
        <p:xfrm>
          <a:off x="767288" y="2738935"/>
          <a:ext cx="4111538" cy="2570893"/>
        </p:xfrm>
        <a:graphic>
          <a:graphicData uri="http://schemas.openxmlformats.org/drawingml/2006/table">
            <a:tbl>
              <a:tblPr/>
              <a:tblGrid>
                <a:gridCol w="557698">
                  <a:extLst>
                    <a:ext uri="{9D8B030D-6E8A-4147-A177-3AD203B41FA5}">
                      <a16:colId xmlns:a16="http://schemas.microsoft.com/office/drawing/2014/main" val="108162123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3051697706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1497963306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3701947100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2100853495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578200990"/>
                    </a:ext>
                  </a:extLst>
                </a:gridCol>
                <a:gridCol w="516168">
                  <a:extLst>
                    <a:ext uri="{9D8B030D-6E8A-4147-A177-3AD203B41FA5}">
                      <a16:colId xmlns:a16="http://schemas.microsoft.com/office/drawing/2014/main" val="2898835782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321081426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1232234328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3031461273"/>
                    </a:ext>
                  </a:extLst>
                </a:gridCol>
              </a:tblGrid>
              <a:tr h="275874"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da-DK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L1Long1</a:t>
                      </a:r>
                    </a:p>
                  </a:txBody>
                  <a:tcPr marL="12527" marR="12527" marT="125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5133557"/>
                  </a:ext>
                </a:extLst>
              </a:tr>
              <a:tr h="527608"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rd </a:t>
                      </a:r>
                      <a:r>
                        <a:rPr lang="da-DK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cc</a:t>
                      </a:r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k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th </a:t>
                      </a:r>
                      <a:r>
                        <a:rPr lang="da-DK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cc</a:t>
                      </a:r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th </a:t>
                      </a:r>
                      <a:r>
                        <a:rPr lang="da-DK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cc</a:t>
                      </a:r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th </a:t>
                      </a:r>
                      <a:r>
                        <a:rPr lang="da-DK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cc</a:t>
                      </a:r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 (EOT)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nd break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th </a:t>
                      </a:r>
                      <a:r>
                        <a:rPr lang="da-DK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cc</a:t>
                      </a:r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OT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6357009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50805130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01699607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6976584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91329589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74538017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09577534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74991192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64287117"/>
                  </a:ext>
                </a:extLst>
              </a:tr>
              <a:tr h="196379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9486634"/>
                  </a:ext>
                </a:extLst>
              </a:tr>
            </a:tbl>
          </a:graphicData>
        </a:graphic>
      </p:graphicFrame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AC29EF4E-6297-4E18-A4AA-D554FEFF1C4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97215781"/>
              </p:ext>
            </p:extLst>
          </p:nvPr>
        </p:nvGraphicFramePr>
        <p:xfrm>
          <a:off x="761700" y="0"/>
          <a:ext cx="4111537" cy="2557733"/>
        </p:xfrm>
        <a:graphic>
          <a:graphicData uri="http://schemas.openxmlformats.org/drawingml/2006/table">
            <a:tbl>
              <a:tblPr/>
              <a:tblGrid>
                <a:gridCol w="557697">
                  <a:extLst>
                    <a:ext uri="{9D8B030D-6E8A-4147-A177-3AD203B41FA5}">
                      <a16:colId xmlns:a16="http://schemas.microsoft.com/office/drawing/2014/main" val="1647416451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1597949407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1061497552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652582410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4096031642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26321148"/>
                    </a:ext>
                  </a:extLst>
                </a:gridCol>
                <a:gridCol w="516168">
                  <a:extLst>
                    <a:ext uri="{9D8B030D-6E8A-4147-A177-3AD203B41FA5}">
                      <a16:colId xmlns:a16="http://schemas.microsoft.com/office/drawing/2014/main" val="1113792001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3997278110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2061633023"/>
                    </a:ext>
                  </a:extLst>
                </a:gridCol>
                <a:gridCol w="379709">
                  <a:extLst>
                    <a:ext uri="{9D8B030D-6E8A-4147-A177-3AD203B41FA5}">
                      <a16:colId xmlns:a16="http://schemas.microsoft.com/office/drawing/2014/main" val="2097589866"/>
                    </a:ext>
                  </a:extLst>
                </a:gridCol>
              </a:tblGrid>
              <a:tr h="274359">
                <a:tc gridSpan="10">
                  <a:txBody>
                    <a:bodyPr/>
                    <a:lstStyle/>
                    <a:p>
                      <a:pPr algn="ctr" fontAlgn="ctr"/>
                      <a:r>
                        <a:rPr lang="da-DK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Long2</a:t>
                      </a:r>
                    </a:p>
                  </a:txBody>
                  <a:tcPr marL="12527" marR="12527" marT="12527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9473455"/>
                  </a:ext>
                </a:extLst>
              </a:tr>
              <a:tr h="524711"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rd vacc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reak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7th vacc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th </a:t>
                      </a:r>
                      <a:r>
                        <a:rPr lang="da-DK" sz="11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vacc</a:t>
                      </a:r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2th vacc. (EOT)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2nd break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15th vacc.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OT</a:t>
                      </a:r>
                    </a:p>
                  </a:txBody>
                  <a:tcPr marL="12527" marR="12527" marT="12527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2490231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1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01652648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R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42350985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3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2817219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4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79404009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5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23905528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6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93263136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8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2114740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9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kumimoji="0" lang="da-DK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uLnTx/>
                        <a:uFillTx/>
                        <a:latin typeface="Calibri" panose="020F0502020204030204" pitchFamily="34" charset="0"/>
                        <a:ea typeface="+mn-ea"/>
                        <a:cs typeface="+mn-cs"/>
                      </a:endParaRP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19546046"/>
                  </a:ext>
                </a:extLst>
              </a:tr>
              <a:tr h="195300">
                <a:tc>
                  <a:txBody>
                    <a:bodyPr/>
                    <a:lstStyle/>
                    <a:p>
                      <a:pPr algn="l" fontAlgn="b"/>
                      <a:r>
                        <a:rPr lang="da-DK" sz="1100" b="1" i="0" u="none" strike="noStrike" dirty="0">
                          <a:effectLst/>
                          <a:latin typeface="Arial" panose="020B0604020202020204" pitchFamily="34" charset="0"/>
                        </a:rPr>
                        <a:t>Pt#12</a:t>
                      </a:r>
                    </a:p>
                  </a:txBody>
                  <a:tcPr marL="9525" marR="9525" marT="952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2527" marR="12527" marT="12527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A6A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35967529"/>
                  </a:ext>
                </a:extLst>
              </a:tr>
            </a:tbl>
          </a:graphicData>
        </a:graphic>
      </p:graphicFrame>
      <p:graphicFrame>
        <p:nvGraphicFramePr>
          <p:cNvPr id="6" name="Table 16">
            <a:extLst>
              <a:ext uri="{FF2B5EF4-FFF2-40B4-BE49-F238E27FC236}">
                <a16:creationId xmlns:a16="http://schemas.microsoft.com/office/drawing/2014/main" id="{437A0EE9-5727-4164-B643-2A873BC5FDB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11843416"/>
              </p:ext>
            </p:extLst>
          </p:nvPr>
        </p:nvGraphicFramePr>
        <p:xfrm>
          <a:off x="876301" y="5576908"/>
          <a:ext cx="3919971" cy="1296332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306657">
                  <a:extLst>
                    <a:ext uri="{9D8B030D-6E8A-4147-A177-3AD203B41FA5}">
                      <a16:colId xmlns:a16="http://schemas.microsoft.com/office/drawing/2014/main" val="1178986384"/>
                    </a:ext>
                  </a:extLst>
                </a:gridCol>
                <a:gridCol w="1306657">
                  <a:extLst>
                    <a:ext uri="{9D8B030D-6E8A-4147-A177-3AD203B41FA5}">
                      <a16:colId xmlns:a16="http://schemas.microsoft.com/office/drawing/2014/main" val="323215878"/>
                    </a:ext>
                  </a:extLst>
                </a:gridCol>
                <a:gridCol w="1306657">
                  <a:extLst>
                    <a:ext uri="{9D8B030D-6E8A-4147-A177-3AD203B41FA5}">
                      <a16:colId xmlns:a16="http://schemas.microsoft.com/office/drawing/2014/main" val="2091973916"/>
                    </a:ext>
                  </a:extLst>
                </a:gridCol>
              </a:tblGrid>
              <a:tr h="222651">
                <a:tc>
                  <a:txBody>
                    <a:bodyPr/>
                    <a:lstStyle/>
                    <a:p>
                      <a:r>
                        <a:rPr lang="en-US" sz="1050" dirty="0"/>
                        <a:t>Peptide</a:t>
                      </a:r>
                    </a:p>
                  </a:txBody>
                  <a:tcPr marL="120248" marR="120248" marT="60124" marB="6012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Baseline</a:t>
                      </a:r>
                    </a:p>
                  </a:txBody>
                  <a:tcPr marL="120248" marR="120248" marT="60124" marB="60124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50" dirty="0"/>
                        <a:t>On treatment</a:t>
                      </a:r>
                    </a:p>
                  </a:txBody>
                  <a:tcPr marL="120248" marR="120248" marT="60124" marB="60124"/>
                </a:tc>
                <a:extLst>
                  <a:ext uri="{0D108BD9-81ED-4DB2-BD59-A6C34878D82A}">
                    <a16:rowId xmlns:a16="http://schemas.microsoft.com/office/drawing/2014/main" val="1725374974"/>
                  </a:ext>
                </a:extLst>
              </a:tr>
              <a:tr h="222651">
                <a:tc>
                  <a:txBody>
                    <a:bodyPr/>
                    <a:lstStyle/>
                    <a:p>
                      <a:r>
                        <a:rPr lang="en-US" sz="1050" dirty="0"/>
                        <a:t>ArgLong2</a:t>
                      </a:r>
                    </a:p>
                  </a:txBody>
                  <a:tcPr marL="120248" marR="120248" marT="60124" marB="60124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6/9</a:t>
                      </a:r>
                    </a:p>
                  </a:txBody>
                  <a:tcPr marL="120248" marR="120248" marT="60124" marB="60124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9/9</a:t>
                      </a:r>
                    </a:p>
                  </a:txBody>
                  <a:tcPr marL="120248" marR="120248" marT="60124" marB="60124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7221767"/>
                  </a:ext>
                </a:extLst>
              </a:tr>
              <a:tr h="222651">
                <a:tc>
                  <a:txBody>
                    <a:bodyPr/>
                    <a:lstStyle/>
                    <a:p>
                      <a:r>
                        <a:rPr lang="en-US" sz="1050" dirty="0"/>
                        <a:t>PDL1Long1</a:t>
                      </a:r>
                    </a:p>
                  </a:txBody>
                  <a:tcPr marL="120248" marR="120248" marT="60124" marB="60124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6/9</a:t>
                      </a:r>
                    </a:p>
                  </a:txBody>
                  <a:tcPr marL="120248" marR="120248" marT="60124" marB="60124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9/9</a:t>
                      </a:r>
                    </a:p>
                  </a:txBody>
                  <a:tcPr marL="120248" marR="120248" marT="60124" marB="60124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7551372"/>
                  </a:ext>
                </a:extLst>
              </a:tr>
              <a:tr h="349775">
                <a:tc>
                  <a:txBody>
                    <a:bodyPr/>
                    <a:lstStyle/>
                    <a:p>
                      <a:r>
                        <a:rPr lang="en-US" sz="1050" dirty="0"/>
                        <a:t>ArgLong2 and/or PDL1Long1</a:t>
                      </a:r>
                    </a:p>
                  </a:txBody>
                  <a:tcPr marL="120248" marR="120248" marT="60124" marB="60124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8/9</a:t>
                      </a:r>
                    </a:p>
                  </a:txBody>
                  <a:tcPr marL="120248" marR="120248" marT="60124" marB="60124" anchor="ctr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9/9</a:t>
                      </a:r>
                    </a:p>
                  </a:txBody>
                  <a:tcPr marL="120248" marR="120248" marT="60124" marB="60124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2417195"/>
                  </a:ext>
                </a:extLst>
              </a:tr>
            </a:tbl>
          </a:graphicData>
        </a:graphic>
      </p:graphicFrame>
      <p:sp>
        <p:nvSpPr>
          <p:cNvPr id="7" name="Tekstfelt 9">
            <a:extLst>
              <a:ext uri="{FF2B5EF4-FFF2-40B4-BE49-F238E27FC236}">
                <a16:creationId xmlns:a16="http://schemas.microsoft.com/office/drawing/2014/main" id="{D6B9A7EA-A657-426E-BAD3-A2EEC0920CB5}"/>
              </a:ext>
            </a:extLst>
          </p:cNvPr>
          <p:cNvSpPr txBox="1"/>
          <p:nvPr/>
        </p:nvSpPr>
        <p:spPr>
          <a:xfrm>
            <a:off x="0" y="0"/>
            <a:ext cx="711186" cy="739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4208" dirty="0"/>
              <a:t>A</a:t>
            </a:r>
            <a:endParaRPr lang="en-US" sz="4208" dirty="0"/>
          </a:p>
        </p:txBody>
      </p:sp>
      <p:sp>
        <p:nvSpPr>
          <p:cNvPr id="8" name="Tekstfelt 10">
            <a:extLst>
              <a:ext uri="{FF2B5EF4-FFF2-40B4-BE49-F238E27FC236}">
                <a16:creationId xmlns:a16="http://schemas.microsoft.com/office/drawing/2014/main" id="{FA130B75-8BED-491C-BE47-3BCCDA0C8584}"/>
              </a:ext>
            </a:extLst>
          </p:cNvPr>
          <p:cNvSpPr txBox="1"/>
          <p:nvPr/>
        </p:nvSpPr>
        <p:spPr>
          <a:xfrm>
            <a:off x="-3892" y="2557733"/>
            <a:ext cx="690493" cy="739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4208" dirty="0"/>
              <a:t>B</a:t>
            </a:r>
            <a:endParaRPr lang="en-US" sz="4208" dirty="0"/>
          </a:p>
        </p:txBody>
      </p:sp>
      <p:sp>
        <p:nvSpPr>
          <p:cNvPr id="9" name="Tekstfelt 12">
            <a:extLst>
              <a:ext uri="{FF2B5EF4-FFF2-40B4-BE49-F238E27FC236}">
                <a16:creationId xmlns:a16="http://schemas.microsoft.com/office/drawing/2014/main" id="{573B7A81-9504-4099-AD1C-20E8025BC2A7}"/>
              </a:ext>
            </a:extLst>
          </p:cNvPr>
          <p:cNvSpPr txBox="1"/>
          <p:nvPr/>
        </p:nvSpPr>
        <p:spPr>
          <a:xfrm>
            <a:off x="10346" y="5309828"/>
            <a:ext cx="683594" cy="739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4208" dirty="0"/>
              <a:t>C</a:t>
            </a:r>
            <a:endParaRPr lang="en-US" sz="4208" dirty="0"/>
          </a:p>
        </p:txBody>
      </p:sp>
      <p:sp>
        <p:nvSpPr>
          <p:cNvPr id="46" name="Tekstfelt 12">
            <a:extLst>
              <a:ext uri="{FF2B5EF4-FFF2-40B4-BE49-F238E27FC236}">
                <a16:creationId xmlns:a16="http://schemas.microsoft.com/office/drawing/2014/main" id="{98D1678C-8F45-4FE7-A0C7-7D3EB1E82C10}"/>
              </a:ext>
            </a:extLst>
          </p:cNvPr>
          <p:cNvSpPr txBox="1"/>
          <p:nvPr/>
        </p:nvSpPr>
        <p:spPr>
          <a:xfrm>
            <a:off x="5430256" y="-375"/>
            <a:ext cx="683594" cy="739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a-DK" sz="4208" dirty="0"/>
              <a:t>D</a:t>
            </a:r>
            <a:endParaRPr lang="en-US" sz="4208" dirty="0"/>
          </a:p>
        </p:txBody>
      </p:sp>
      <p:graphicFrame>
        <p:nvGraphicFramePr>
          <p:cNvPr id="47" name="Table 46">
            <a:extLst>
              <a:ext uri="{FF2B5EF4-FFF2-40B4-BE49-F238E27FC236}">
                <a16:creationId xmlns:a16="http://schemas.microsoft.com/office/drawing/2014/main" id="{89822366-526B-47B2-A278-19C6C1929F1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16655977"/>
              </p:ext>
            </p:extLst>
          </p:nvPr>
        </p:nvGraphicFramePr>
        <p:xfrm>
          <a:off x="6946084" y="86309"/>
          <a:ext cx="3886836" cy="2452573"/>
        </p:xfrm>
        <a:graphic>
          <a:graphicData uri="http://schemas.openxmlformats.org/drawingml/2006/table">
            <a:tbl>
              <a:tblPr/>
              <a:tblGrid>
                <a:gridCol w="859310">
                  <a:extLst>
                    <a:ext uri="{9D8B030D-6E8A-4147-A177-3AD203B41FA5}">
                      <a16:colId xmlns:a16="http://schemas.microsoft.com/office/drawing/2014/main" val="2301793464"/>
                    </a:ext>
                  </a:extLst>
                </a:gridCol>
                <a:gridCol w="846681">
                  <a:extLst>
                    <a:ext uri="{9D8B030D-6E8A-4147-A177-3AD203B41FA5}">
                      <a16:colId xmlns:a16="http://schemas.microsoft.com/office/drawing/2014/main" val="1535623543"/>
                    </a:ext>
                  </a:extLst>
                </a:gridCol>
                <a:gridCol w="1077594">
                  <a:extLst>
                    <a:ext uri="{9D8B030D-6E8A-4147-A177-3AD203B41FA5}">
                      <a16:colId xmlns:a16="http://schemas.microsoft.com/office/drawing/2014/main" val="2265688347"/>
                    </a:ext>
                  </a:extLst>
                </a:gridCol>
                <a:gridCol w="1103251">
                  <a:extLst>
                    <a:ext uri="{9D8B030D-6E8A-4147-A177-3AD203B41FA5}">
                      <a16:colId xmlns:a16="http://schemas.microsoft.com/office/drawing/2014/main" val="1975919297"/>
                    </a:ext>
                  </a:extLst>
                </a:gridCol>
              </a:tblGrid>
              <a:tr h="301113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da-DK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rgLong2 </a:t>
                      </a:r>
                    </a:p>
                  </a:txBody>
                  <a:tcPr marL="13024" marR="13024" marT="130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30788288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rd/7th vacc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th/12th vacc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90637964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1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76418981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2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94219867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3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270863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4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9345019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5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23863078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6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01193323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8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81989386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9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88697361"/>
                  </a:ext>
                </a:extLst>
              </a:tr>
              <a:tr h="215146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12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5335323"/>
                  </a:ext>
                </a:extLst>
              </a:tr>
            </a:tbl>
          </a:graphicData>
        </a:graphic>
      </p:graphicFrame>
      <p:graphicFrame>
        <p:nvGraphicFramePr>
          <p:cNvPr id="48" name="Table 47">
            <a:extLst>
              <a:ext uri="{FF2B5EF4-FFF2-40B4-BE49-F238E27FC236}">
                <a16:creationId xmlns:a16="http://schemas.microsoft.com/office/drawing/2014/main" id="{F9FDA228-8E3C-4EE9-8C13-E9EAAB80956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0602658"/>
              </p:ext>
            </p:extLst>
          </p:nvPr>
        </p:nvGraphicFramePr>
        <p:xfrm>
          <a:off x="6937695" y="2757900"/>
          <a:ext cx="3923523" cy="2452575"/>
        </p:xfrm>
        <a:graphic>
          <a:graphicData uri="http://schemas.openxmlformats.org/drawingml/2006/table">
            <a:tbl>
              <a:tblPr/>
              <a:tblGrid>
                <a:gridCol w="852292">
                  <a:extLst>
                    <a:ext uri="{9D8B030D-6E8A-4147-A177-3AD203B41FA5}">
                      <a16:colId xmlns:a16="http://schemas.microsoft.com/office/drawing/2014/main" val="3876494695"/>
                    </a:ext>
                  </a:extLst>
                </a:gridCol>
                <a:gridCol w="909084">
                  <a:extLst>
                    <a:ext uri="{9D8B030D-6E8A-4147-A177-3AD203B41FA5}">
                      <a16:colId xmlns:a16="http://schemas.microsoft.com/office/drawing/2014/main" val="1427488612"/>
                    </a:ext>
                  </a:extLst>
                </a:gridCol>
                <a:gridCol w="1019649">
                  <a:extLst>
                    <a:ext uri="{9D8B030D-6E8A-4147-A177-3AD203B41FA5}">
                      <a16:colId xmlns:a16="http://schemas.microsoft.com/office/drawing/2014/main" val="1051957813"/>
                    </a:ext>
                  </a:extLst>
                </a:gridCol>
                <a:gridCol w="1142498">
                  <a:extLst>
                    <a:ext uri="{9D8B030D-6E8A-4147-A177-3AD203B41FA5}">
                      <a16:colId xmlns:a16="http://schemas.microsoft.com/office/drawing/2014/main" val="3864378767"/>
                    </a:ext>
                  </a:extLst>
                </a:gridCol>
              </a:tblGrid>
              <a:tr h="298195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da-DK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DL1Long1</a:t>
                      </a:r>
                      <a:endParaRPr lang="da-DK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81627406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Baseline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3rd/7th vacc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a-DK" sz="12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9th/12th vacc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1077727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1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80670194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2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8892563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3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9900286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4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6256779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5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7500892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6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00099233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8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1425298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9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DR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7170390"/>
                  </a:ext>
                </a:extLst>
              </a:tr>
              <a:tr h="215438">
                <a:tc>
                  <a:txBody>
                    <a:bodyPr/>
                    <a:lstStyle/>
                    <a:p>
                      <a:pPr algn="l" fontAlgn="b"/>
                      <a:r>
                        <a:rPr lang="da-DK" sz="1200" b="1" i="0" u="none" strike="noStrike" dirty="0">
                          <a:effectLst/>
                          <a:latin typeface="Arial" panose="020B0604020202020204" pitchFamily="34" charset="0"/>
                        </a:rPr>
                        <a:t>Pt#12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>
                          <a:solidFill>
                            <a:srgbClr val="808080"/>
                          </a:solidFill>
                          <a:effectLst/>
                          <a:latin typeface="Calibri" panose="020F0502020204030204" pitchFamily="34" charset="0"/>
                        </a:rPr>
                        <a:t>ns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a-DK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*</a:t>
                      </a: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kumimoji="0" lang="da-DK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*</a:t>
                      </a:r>
                      <a:endParaRPr lang="da-DK" sz="12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13024" marR="13024" marT="13024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259660"/>
                  </a:ext>
                </a:extLst>
              </a:tr>
            </a:tbl>
          </a:graphicData>
        </a:graphic>
      </p:graphicFrame>
      <p:graphicFrame>
        <p:nvGraphicFramePr>
          <p:cNvPr id="49" name="Table 16">
            <a:extLst>
              <a:ext uri="{FF2B5EF4-FFF2-40B4-BE49-F238E27FC236}">
                <a16:creationId xmlns:a16="http://schemas.microsoft.com/office/drawing/2014/main" id="{E1FBCB54-C54F-4F60-93A1-C7E47CDAA14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4842710"/>
              </p:ext>
            </p:extLst>
          </p:nvPr>
        </p:nvGraphicFramePr>
        <p:xfrm>
          <a:off x="7066612" y="5467022"/>
          <a:ext cx="3654518" cy="1338328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1590827">
                  <a:extLst>
                    <a:ext uri="{9D8B030D-6E8A-4147-A177-3AD203B41FA5}">
                      <a16:colId xmlns:a16="http://schemas.microsoft.com/office/drawing/2014/main" val="1178986384"/>
                    </a:ext>
                  </a:extLst>
                </a:gridCol>
                <a:gridCol w="1010040">
                  <a:extLst>
                    <a:ext uri="{9D8B030D-6E8A-4147-A177-3AD203B41FA5}">
                      <a16:colId xmlns:a16="http://schemas.microsoft.com/office/drawing/2014/main" val="323215878"/>
                    </a:ext>
                  </a:extLst>
                </a:gridCol>
                <a:gridCol w="1053651">
                  <a:extLst>
                    <a:ext uri="{9D8B030D-6E8A-4147-A177-3AD203B41FA5}">
                      <a16:colId xmlns:a16="http://schemas.microsoft.com/office/drawing/2014/main" val="2091973916"/>
                    </a:ext>
                  </a:extLst>
                </a:gridCol>
              </a:tblGrid>
              <a:tr h="268642">
                <a:tc>
                  <a:txBody>
                    <a:bodyPr/>
                    <a:lstStyle/>
                    <a:p>
                      <a:r>
                        <a:rPr lang="en-US" sz="1100" dirty="0"/>
                        <a:t>Peptide</a:t>
                      </a:r>
                    </a:p>
                  </a:txBody>
                  <a:tcPr marL="125031" marR="125031" marT="62516" marB="6251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Baseline</a:t>
                      </a:r>
                    </a:p>
                  </a:txBody>
                  <a:tcPr marL="125031" marR="125031" marT="62516" marB="62516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On treatment</a:t>
                      </a:r>
                    </a:p>
                  </a:txBody>
                  <a:tcPr marL="125031" marR="125031" marT="62516" marB="62516"/>
                </a:tc>
                <a:extLst>
                  <a:ext uri="{0D108BD9-81ED-4DB2-BD59-A6C34878D82A}">
                    <a16:rowId xmlns:a16="http://schemas.microsoft.com/office/drawing/2014/main" val="1725374974"/>
                  </a:ext>
                </a:extLst>
              </a:tr>
              <a:tr h="268642">
                <a:tc>
                  <a:txBody>
                    <a:bodyPr/>
                    <a:lstStyle/>
                    <a:p>
                      <a:r>
                        <a:rPr lang="en-US" sz="1100" b="0" dirty="0"/>
                        <a:t>ArgLong2</a:t>
                      </a:r>
                    </a:p>
                  </a:txBody>
                  <a:tcPr marL="125031" marR="125031" marT="62516" marB="62516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1/9</a:t>
                      </a:r>
                    </a:p>
                  </a:txBody>
                  <a:tcPr marL="125031" marR="125031" marT="62516" marB="62516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5/9</a:t>
                      </a:r>
                    </a:p>
                  </a:txBody>
                  <a:tcPr marL="125031" marR="125031" marT="62516" marB="6251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17221767"/>
                  </a:ext>
                </a:extLst>
              </a:tr>
              <a:tr h="268642">
                <a:tc>
                  <a:txBody>
                    <a:bodyPr/>
                    <a:lstStyle/>
                    <a:p>
                      <a:r>
                        <a:rPr lang="en-US" sz="1100" b="0" dirty="0"/>
                        <a:t>PDL1Long1</a:t>
                      </a:r>
                    </a:p>
                  </a:txBody>
                  <a:tcPr marL="125031" marR="125031" marT="62516" marB="62516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3/9</a:t>
                      </a:r>
                    </a:p>
                  </a:txBody>
                  <a:tcPr marL="125031" marR="125031" marT="62516" marB="62516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8/9</a:t>
                      </a:r>
                    </a:p>
                  </a:txBody>
                  <a:tcPr marL="125031" marR="125031" marT="62516" marB="6251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47551372"/>
                  </a:ext>
                </a:extLst>
              </a:tr>
              <a:tr h="422517">
                <a:tc>
                  <a:txBody>
                    <a:bodyPr/>
                    <a:lstStyle/>
                    <a:p>
                      <a:r>
                        <a:rPr lang="en-US" sz="1100" b="0" dirty="0"/>
                        <a:t>ArgLong2 and/or PDL1Long1</a:t>
                      </a:r>
                    </a:p>
                  </a:txBody>
                  <a:tcPr marL="125031" marR="125031" marT="62516" marB="62516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4/9</a:t>
                      </a:r>
                    </a:p>
                  </a:txBody>
                  <a:tcPr marL="125031" marR="125031" marT="62516" marB="62516"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100" dirty="0"/>
                        <a:t>8/9</a:t>
                      </a:r>
                    </a:p>
                  </a:txBody>
                  <a:tcPr marL="125031" marR="125031" marT="62516" marB="62516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82417195"/>
                  </a:ext>
                </a:extLst>
              </a:tr>
            </a:tbl>
          </a:graphicData>
        </a:graphic>
      </p:graphicFrame>
      <p:sp>
        <p:nvSpPr>
          <p:cNvPr id="50" name="Tekstfelt 2">
            <a:extLst>
              <a:ext uri="{FF2B5EF4-FFF2-40B4-BE49-F238E27FC236}">
                <a16:creationId xmlns:a16="http://schemas.microsoft.com/office/drawing/2014/main" id="{330B05DE-3CE1-497B-B0A5-D9313D873C5F}"/>
              </a:ext>
            </a:extLst>
          </p:cNvPr>
          <p:cNvSpPr txBox="1"/>
          <p:nvPr/>
        </p:nvSpPr>
        <p:spPr>
          <a:xfrm>
            <a:off x="5442492" y="2517877"/>
            <a:ext cx="458780" cy="7657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4376" dirty="0"/>
              <a:t>E</a:t>
            </a:r>
            <a:endParaRPr lang="en-US" sz="4376" dirty="0"/>
          </a:p>
        </p:txBody>
      </p:sp>
      <p:sp>
        <p:nvSpPr>
          <p:cNvPr id="52" name="Tekstfelt 9">
            <a:extLst>
              <a:ext uri="{FF2B5EF4-FFF2-40B4-BE49-F238E27FC236}">
                <a16:creationId xmlns:a16="http://schemas.microsoft.com/office/drawing/2014/main" id="{CD9D764E-1AF6-4D98-BBD9-41D3A700273E}"/>
              </a:ext>
            </a:extLst>
          </p:cNvPr>
          <p:cNvSpPr txBox="1"/>
          <p:nvPr/>
        </p:nvSpPr>
        <p:spPr>
          <a:xfrm>
            <a:off x="5416844" y="5279247"/>
            <a:ext cx="442750" cy="76572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4376" dirty="0"/>
              <a:t>F</a:t>
            </a:r>
            <a:endParaRPr lang="en-US" sz="4376" dirty="0"/>
          </a:p>
        </p:txBody>
      </p:sp>
    </p:spTree>
    <p:extLst>
      <p:ext uri="{BB962C8B-B14F-4D97-AF65-F5344CB8AC3E}">
        <p14:creationId xmlns:p14="http://schemas.microsoft.com/office/powerpoint/2010/main" val="22666722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0</TotalTime>
  <Words>436</Words>
  <Application>Microsoft Office PowerPoint</Application>
  <PresentationFormat>Widescreen</PresentationFormat>
  <Paragraphs>3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velina Martinenaite</dc:creator>
  <cp:lastModifiedBy>Evelina Martinenaite</cp:lastModifiedBy>
  <cp:revision>4</cp:revision>
  <dcterms:created xsi:type="dcterms:W3CDTF">2022-11-16T12:24:05Z</dcterms:created>
  <dcterms:modified xsi:type="dcterms:W3CDTF">2022-11-21T15:54:40Z</dcterms:modified>
</cp:coreProperties>
</file>